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8" d="100"/>
          <a:sy n="58" d="100"/>
        </p:scale>
        <p:origin x="57" y="3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6128BF6-0413-6973-75F7-B8C9FD5343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2B2F175-937F-3B1E-BEFF-71CCEF39AA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924752F-1433-DCC5-E514-325E043FA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ECA8F-C70C-4A47-9273-2F3D3EB9C197}" type="datetimeFigureOut">
              <a:rPr lang="zh-CN" altLang="en-US" smtClean="0"/>
              <a:t>2024/7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C22D90F-3970-5FFE-A689-492BA7AC55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A07B6EE-778F-A732-F262-1FF2EC2A46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92CA6-0691-4ACA-95C2-7A34273E1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37165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40694E-1ABB-1E76-DD3A-72D39987C3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46E04FD-9582-5EBA-4F77-EB8CCAE3A3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F3F2655-B4F2-A1E1-587C-B1430B45FE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ECA8F-C70C-4A47-9273-2F3D3EB9C197}" type="datetimeFigureOut">
              <a:rPr lang="zh-CN" altLang="en-US" smtClean="0"/>
              <a:t>2024/7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8172D55-88FE-CFC8-C7F1-DBBBAD5A7D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CACAA8C-9E48-6243-F530-11F4DE4839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92CA6-0691-4ACA-95C2-7A34273E1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2456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28D977B-11B4-2DA9-E53D-0E500416ED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67A69D1-80EF-97BB-73EA-2DED28704B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2C8E101-84FC-8B56-A303-1944444207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ECA8F-C70C-4A47-9273-2F3D3EB9C197}" type="datetimeFigureOut">
              <a:rPr lang="zh-CN" altLang="en-US" smtClean="0"/>
              <a:t>2024/7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AF9F5CF-B931-FCD7-55FE-D7D1C2AF0C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23044D-BAA2-F43F-5B81-7153D1ED56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92CA6-0691-4ACA-95C2-7A34273E1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2228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8DF158-FDFC-5D2D-BA74-1A6BEA00E7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EA6D04D-E10C-D405-C8F0-D21B9756CE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6408F7C-9A41-F3A0-8EF8-3E2108F5EE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ECA8F-C70C-4A47-9273-2F3D3EB9C197}" type="datetimeFigureOut">
              <a:rPr lang="zh-CN" altLang="en-US" smtClean="0"/>
              <a:t>2024/7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FE8203-1490-CB4F-7BBF-03C4DF1635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B2A3BB9-A19F-53CD-091A-93431B0022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92CA6-0691-4ACA-95C2-7A34273E1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9349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32C7C8-9279-DE9C-034C-6E42E794FB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8C7D149-021C-5A7E-8A5F-593555EF50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D8035AD-7D79-42F7-FCB6-0A87B48638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ECA8F-C70C-4A47-9273-2F3D3EB9C197}" type="datetimeFigureOut">
              <a:rPr lang="zh-CN" altLang="en-US" smtClean="0"/>
              <a:t>2024/7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8F32F9E-8A30-50D2-1774-A4D9A8CA82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057B10C-1264-C849-97BF-391F2094E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92CA6-0691-4ACA-95C2-7A34273E1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9714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BB02F5-56E6-5ECE-78A0-CA2B5DF504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4F1F040-053B-506A-63BB-76CBE651D75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21EF63A-5A80-06B4-2CF1-3D7C56BD36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E71545D-D861-8D71-A93E-C2887BBFD0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ECA8F-C70C-4A47-9273-2F3D3EB9C197}" type="datetimeFigureOut">
              <a:rPr lang="zh-CN" altLang="en-US" smtClean="0"/>
              <a:t>2024/7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A78657B-8A38-5FBF-B19D-BF4CA48D70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7333E9E-AFD3-74F7-368C-3470D3013B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92CA6-0691-4ACA-95C2-7A34273E1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64687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B0484FE-BAAF-3C2B-1C5A-12A5E165AA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65730D8-9E42-1E06-FC54-C6CBE823A2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04968F6-815C-5088-88F8-69415D731D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C844F27-89A6-9053-D335-2858BF4964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7420D49-82FD-4051-74CF-F6A03870C4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762ACD5-B51B-90D3-387A-0B38EF755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ECA8F-C70C-4A47-9273-2F3D3EB9C197}" type="datetimeFigureOut">
              <a:rPr lang="zh-CN" altLang="en-US" smtClean="0"/>
              <a:t>2024/7/1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DCB95C2-5DA8-83BC-D42A-233BFB1EBC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E002526-92D0-43D4-4B63-AC38CE380B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92CA6-0691-4ACA-95C2-7A34273E1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53990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5460323-80D2-C8CD-9EAE-C6EE6E986A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E2EFAFC-410A-6E0C-3376-9400C86D59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ECA8F-C70C-4A47-9273-2F3D3EB9C197}" type="datetimeFigureOut">
              <a:rPr lang="zh-CN" altLang="en-US" smtClean="0"/>
              <a:t>2024/7/1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18EA0BD-D919-7136-7482-74873BCC48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73BB4F6-3132-97A8-3541-928C1FD3D8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92CA6-0691-4ACA-95C2-7A34273E1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04190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0862B7B-27B7-43D4-E3E5-2F47321B4F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ECA8F-C70C-4A47-9273-2F3D3EB9C197}" type="datetimeFigureOut">
              <a:rPr lang="zh-CN" altLang="en-US" smtClean="0"/>
              <a:t>2024/7/1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FB82D23-E31D-5767-B630-638C76E438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328A486-3EEC-EB45-208A-EBA2B95DA8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92CA6-0691-4ACA-95C2-7A34273E1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6356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3950F4F-821B-6638-6EE7-DDF616745A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3AC9CD6-436C-A622-F035-0FE8DEEDED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ACBEECE-F1D5-4A1F-5987-97C2396C2E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5EA7B7E-DB49-A412-6C4F-54AB5D144D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ECA8F-C70C-4A47-9273-2F3D3EB9C197}" type="datetimeFigureOut">
              <a:rPr lang="zh-CN" altLang="en-US" smtClean="0"/>
              <a:t>2024/7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074829C-2337-5024-9F11-C202E5170B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F143895-B7F2-86B6-8B35-26B8C24010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92CA6-0691-4ACA-95C2-7A34273E1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10695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00B295-B07C-8B8F-D09C-3436FF3382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86B9AA4-A341-44EF-2F93-12DABF6C47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4C24666-9DA5-D04D-7895-60F50C7E70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87848EB-A396-79CA-04B8-4CFC67008D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ECA8F-C70C-4A47-9273-2F3D3EB9C197}" type="datetimeFigureOut">
              <a:rPr lang="zh-CN" altLang="en-US" smtClean="0"/>
              <a:t>2024/7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614168A-17BD-B8C3-3124-08F1CBE211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4FA26C8-6165-EFE3-A82F-15E6C2D451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92CA6-0691-4ACA-95C2-7A34273E1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59597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503B7EA-3B58-1E79-8B3C-F3B0DD0994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696C3B7-8D6E-C7DF-41B1-7B84EC0CC0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35BBA0C-FB81-0A99-8B1E-18DBB7FFA03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2ECA8F-C70C-4A47-9273-2F3D3EB9C197}" type="datetimeFigureOut">
              <a:rPr lang="zh-CN" altLang="en-US" smtClean="0"/>
              <a:t>2024/7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741CB86-F83C-5D6D-3B00-12D84FF1E4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2DBD2E1-A8F2-27DE-4D53-616CFF8F9A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F92CA6-0691-4ACA-95C2-7A34273E1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50502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>
            <a:extLst>
              <a:ext uri="{FF2B5EF4-FFF2-40B4-BE49-F238E27FC236}">
                <a16:creationId xmlns:a16="http://schemas.microsoft.com/office/drawing/2014/main" id="{EE125851-8BA0-D681-020A-33CC006D6E59}"/>
              </a:ext>
            </a:extLst>
          </p:cNvPr>
          <p:cNvGrpSpPr/>
          <p:nvPr/>
        </p:nvGrpSpPr>
        <p:grpSpPr>
          <a:xfrm>
            <a:off x="1519707" y="1234523"/>
            <a:ext cx="8377704" cy="4478182"/>
            <a:chOff x="1519707" y="1234523"/>
            <a:chExt cx="8377704" cy="4478182"/>
          </a:xfrm>
        </p:grpSpPr>
        <p:grpSp>
          <p:nvGrpSpPr>
            <p:cNvPr id="29" name="组合 28">
              <a:extLst>
                <a:ext uri="{FF2B5EF4-FFF2-40B4-BE49-F238E27FC236}">
                  <a16:creationId xmlns:a16="http://schemas.microsoft.com/office/drawing/2014/main" id="{194B78AF-8AA6-915D-562E-AF7DF3AF8E9C}"/>
                </a:ext>
              </a:extLst>
            </p:cNvPr>
            <p:cNvGrpSpPr/>
            <p:nvPr/>
          </p:nvGrpSpPr>
          <p:grpSpPr>
            <a:xfrm>
              <a:off x="1519707" y="1234523"/>
              <a:ext cx="8377704" cy="3921554"/>
              <a:chOff x="1510420" y="653980"/>
              <a:chExt cx="9476099" cy="4502097"/>
            </a:xfrm>
          </p:grpSpPr>
          <p:sp>
            <p:nvSpPr>
              <p:cNvPr id="4" name="文本框 3">
                <a:extLst>
                  <a:ext uri="{FF2B5EF4-FFF2-40B4-BE49-F238E27FC236}">
                    <a16:creationId xmlns:a16="http://schemas.microsoft.com/office/drawing/2014/main" id="{3060454F-3637-7060-C5DD-C08687A89934}"/>
                  </a:ext>
                </a:extLst>
              </p:cNvPr>
              <p:cNvSpPr txBox="1"/>
              <p:nvPr/>
            </p:nvSpPr>
            <p:spPr>
              <a:xfrm>
                <a:off x="1510420" y="653980"/>
                <a:ext cx="5176286" cy="38867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tients with BAV and aortic stenosis (n=215)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" name="文本框 4">
                <a:extLst>
                  <a:ext uri="{FF2B5EF4-FFF2-40B4-BE49-F238E27FC236}">
                    <a16:creationId xmlns:a16="http://schemas.microsoft.com/office/drawing/2014/main" id="{B3922730-F80D-746C-8DBC-7DB7B47004BA}"/>
                  </a:ext>
                </a:extLst>
              </p:cNvPr>
              <p:cNvSpPr txBox="1"/>
              <p:nvPr/>
            </p:nvSpPr>
            <p:spPr>
              <a:xfrm>
                <a:off x="1590540" y="4817523"/>
                <a:ext cx="5096167" cy="338554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86 BAV patients meeting inclusion criteria 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7" name="直接箭头连接符 6">
                <a:extLst>
                  <a:ext uri="{FF2B5EF4-FFF2-40B4-BE49-F238E27FC236}">
                    <a16:creationId xmlns:a16="http://schemas.microsoft.com/office/drawing/2014/main" id="{BB269144-29C0-446C-135F-2A4FE9092C84}"/>
                  </a:ext>
                </a:extLst>
              </p:cNvPr>
              <p:cNvCxnSpPr>
                <a:cxnSpLocks/>
                <a:stCxn id="4" idx="2"/>
                <a:endCxn id="5" idx="0"/>
              </p:cNvCxnSpPr>
              <p:nvPr/>
            </p:nvCxnSpPr>
            <p:spPr>
              <a:xfrm>
                <a:off x="4098563" y="1042653"/>
                <a:ext cx="40060" cy="3774869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直接箭头连接符 10">
                <a:extLst>
                  <a:ext uri="{FF2B5EF4-FFF2-40B4-BE49-F238E27FC236}">
                    <a16:creationId xmlns:a16="http://schemas.microsoft.com/office/drawing/2014/main" id="{36B2FFB7-60D5-1CED-8775-EC0819D3F91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38624" y="2730320"/>
                <a:ext cx="1041903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E83A762E-8C21-9F85-6294-812BD18205E7}"/>
                  </a:ext>
                </a:extLst>
              </p:cNvPr>
              <p:cNvSpPr txBox="1"/>
              <p:nvPr/>
            </p:nvSpPr>
            <p:spPr>
              <a:xfrm>
                <a:off x="5180528" y="1649232"/>
                <a:ext cx="5805991" cy="236737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xclusion criteria:</a:t>
                </a:r>
              </a:p>
              <a:p>
                <a:pPr algn="just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) moderate or severe co-existing aortic regurgitation(n=86)</a:t>
                </a:r>
              </a:p>
              <a:p>
                <a:pPr algn="just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) greater than moderate mitral/tricuspid regurgitation(n=11)</a:t>
                </a:r>
              </a:p>
              <a:p>
                <a:pPr algn="just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) history of myocardial infarction(n=3)</a:t>
                </a:r>
              </a:p>
              <a:p>
                <a:pPr algn="just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) hematologic and rheumatology diagnoses(n=4) </a:t>
                </a:r>
              </a:p>
              <a:p>
                <a:pPr algn="just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) cardiomyopathy and Marfan Syndrome(n=3)</a:t>
                </a:r>
              </a:p>
              <a:p>
                <a:pPr algn="just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)presence of atrial fibrillation(n=15) </a:t>
                </a:r>
              </a:p>
              <a:p>
                <a:pPr algn="just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) poor image quality(n=7)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6705490A-D306-C0A0-8B05-2E4BE4A82940}"/>
                </a:ext>
              </a:extLst>
            </p:cNvPr>
            <p:cNvSpPr txBox="1"/>
            <p:nvPr/>
          </p:nvSpPr>
          <p:spPr>
            <a:xfrm>
              <a:off x="1519707" y="5374151"/>
              <a:ext cx="6094926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1. </a:t>
              </a:r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Study flowchart.</a:t>
              </a:r>
              <a:endPara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955703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109</Words>
  <Application>Microsoft Office PowerPoint</Application>
  <PresentationFormat>宽屏</PresentationFormat>
  <Paragraphs>1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文惠 邓</dc:creator>
  <cp:lastModifiedBy>文惠 邓</cp:lastModifiedBy>
  <cp:revision>26</cp:revision>
  <dcterms:created xsi:type="dcterms:W3CDTF">2024-07-09T08:06:07Z</dcterms:created>
  <dcterms:modified xsi:type="dcterms:W3CDTF">2024-07-11T10:38:46Z</dcterms:modified>
</cp:coreProperties>
</file>